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0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1936">
          <p15:clr>
            <a:srgbClr val="A4A3A4"/>
          </p15:clr>
        </p15:guide>
        <p15:guide id="3" pos="34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ortier, Stephanie" initials="FS" lastIdx="4" clrIdx="0">
    <p:extLst/>
  </p:cmAuthor>
  <p:cmAuthor id="2" name="Andrew Stiff" initials="" lastIdx="0" clrIdx="1"/>
  <p:cmAuthor id="3" name="Sobrina Wesolowski" initials="SW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00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803" autoAdjust="0"/>
    <p:restoredTop sz="93918" autoAdjust="0"/>
  </p:normalViewPr>
  <p:slideViewPr>
    <p:cSldViewPr snapToGrid="0">
      <p:cViewPr varScale="1">
        <p:scale>
          <a:sx n="48" d="100"/>
          <a:sy n="48" d="100"/>
        </p:scale>
        <p:origin x="-3108" y="-120"/>
      </p:cViewPr>
      <p:guideLst>
        <p:guide orient="horz" pos="3840"/>
        <p:guide pos="1936"/>
        <p:guide pos="3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BB1863-6C78-4199-A00B-2F07DD958D56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426DA3-EA64-413C-AC60-7E90D2A03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8213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207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550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053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273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722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786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509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666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45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74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645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443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ontent Placeholder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94970882"/>
              </p:ext>
            </p:extLst>
          </p:nvPr>
        </p:nvGraphicFramePr>
        <p:xfrm>
          <a:off x="309868" y="603566"/>
          <a:ext cx="6232821" cy="227582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2922063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1497724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  <a:gridCol w="1813034">
                  <a:extLst>
                    <a:ext uri="{9D8B030D-6E8A-4147-A177-3AD203B41FA5}">
                      <a16:colId xmlns:a16="http://schemas.microsoft.com/office/drawing/2014/main" xmlns="" val="20002"/>
                    </a:ext>
                  </a:extLst>
                </a:gridCol>
              </a:tblGrid>
              <a:tr h="501862">
                <a:tc>
                  <a:txBody>
                    <a:bodyPr/>
                    <a:lstStyle/>
                    <a:p>
                      <a:endPara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NAC cohort</a:t>
                      </a:r>
                      <a:r>
                        <a:rPr lang="en-US" sz="140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  <a:p>
                      <a:pPr algn="ctr"/>
                      <a:r>
                        <a:rPr lang="en-US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NAC</a:t>
                      </a:r>
                      <a:r>
                        <a:rPr lang="en-US" sz="1400" b="1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hort</a:t>
                      </a:r>
                    </a:p>
                    <a:p>
                      <a:pPr algn="ctr"/>
                      <a:r>
                        <a:rPr lang="en-US" sz="14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=17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0">
                <a:tc>
                  <a:txBody>
                    <a:bodyPr/>
                    <a:lstStyle/>
                    <a:p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b="1" i="0" u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r>
                        <a:rPr lang="en-US" sz="1400" b="1" i="0" u="none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b="1" i="0" u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range)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1" i="0" u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an</a:t>
                      </a:r>
                      <a:r>
                        <a:rPr lang="en-US" sz="1400" b="1" i="0" u="none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b="1" i="0" u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range)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xmlns="" val="1863296630"/>
                  </a:ext>
                </a:extLst>
              </a:tr>
              <a:tr h="273219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PD-L1 intensity</a:t>
                      </a:r>
                      <a:endParaRPr lang="en-US" sz="14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6% (0-10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8%</a:t>
                      </a:r>
                      <a:r>
                        <a:rPr lang="en-US" sz="14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0-15%)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298306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ntra-</a:t>
                      </a:r>
                      <a:r>
                        <a:rPr lang="en-US" sz="1400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al</a:t>
                      </a: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PD-L1 intensity</a:t>
                      </a:r>
                      <a:endParaRPr lang="en-US" sz="14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%</a:t>
                      </a:r>
                      <a:r>
                        <a:rPr lang="en-US" sz="14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0-15%)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4%</a:t>
                      </a:r>
                      <a:r>
                        <a:rPr lang="en-US" sz="14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0-30%)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325100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tromal PD-L1+ intensity</a:t>
                      </a:r>
                      <a:endParaRPr lang="en-US" sz="14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%</a:t>
                      </a:r>
                      <a:r>
                        <a:rPr lang="en-US" sz="14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0-3%)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%</a:t>
                      </a:r>
                      <a:r>
                        <a:rPr lang="en-US" sz="1400" baseline="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0-15%)</a:t>
                      </a:r>
                      <a:endParaRPr lang="en-US" sz="14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194553">
                <a:tc>
                  <a:txBody>
                    <a:bodyPr/>
                    <a:lstStyle/>
                    <a:p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verall PD-1+ intensity</a:t>
                      </a:r>
                      <a:endParaRPr lang="en-US" sz="1400" baseline="300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2% (0-5%)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4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2% (0-1%)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</a:tbl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309868" y="282780"/>
            <a:ext cx="610584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5. Intensity of PD-L1/PD-1 expression</a:t>
            </a:r>
          </a:p>
        </p:txBody>
      </p:sp>
    </p:spTree>
    <p:extLst>
      <p:ext uri="{BB962C8B-B14F-4D97-AF65-F5344CB8AC3E}">
        <p14:creationId xmlns:p14="http://schemas.microsoft.com/office/powerpoint/2010/main" val="27186237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28</TotalTime>
  <Words>76</Words>
  <Application>Microsoft Office PowerPoint</Application>
  <PresentationFormat>Custom</PresentationFormat>
  <Paragraphs>1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he Ohio State University Wexner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iff, Andrew</dc:creator>
  <cp:lastModifiedBy>MPABLEO</cp:lastModifiedBy>
  <cp:revision>188</cp:revision>
  <dcterms:created xsi:type="dcterms:W3CDTF">2018-09-28T15:43:32Z</dcterms:created>
  <dcterms:modified xsi:type="dcterms:W3CDTF">2020-05-13T11:11:18Z</dcterms:modified>
</cp:coreProperties>
</file>